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85DC8-A64E-41DC-AA1A-5535FE5A95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5074E-BC6E-403F-B27F-23BB494022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CDA9AE-D532-4998-B7E5-57EA73A1A1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6CCD68-B425-4B78-BBED-8B79D6E4E1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0338C-56CB-413F-979D-AE88EF8B6F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7B658-0E9D-441A-98D4-A01FB274A5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678B0-2285-4B7F-971B-F539FE2ED6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8E9B1-64D4-466C-BB70-8DCACEEA89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6A48C-4079-483C-B252-36D2937765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8EFE3-2513-4414-8681-BDCC1C91E9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D992A7-D211-4862-94E7-AE4FEF2583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2B574-8371-45A8-BC2E-42C581D283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53F749-738B-4C6B-9087-AD86D4C2782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C:\Documents and Settings\ncmlwl\Desktop\Histo Pics\4-1-10_Histo Pics\4-1-10_RCC07-0408_Vehicle,TKI&amp;RAD001_T5 days\TKI 50\P1040024.JPG"/>
          <p:cNvPicPr/>
          <p:nvPr/>
        </p:nvPicPr>
        <p:blipFill>
          <a:blip r:embed="rId1"/>
          <a:stretch/>
        </p:blipFill>
        <p:spPr>
          <a:xfrm>
            <a:off x="47520" y="2239920"/>
            <a:ext cx="2978280" cy="23781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1" descr="C:\Documents and Settings\ncmlwl\Desktop\Histo Pics\4-1-10_Histo Pics\4-1-10_RCC25-0908_Vehicle,TKI&amp;RAD001_T22 days\RAD001 2.5\P1040011.JPG"/>
          <p:cNvPicPr/>
          <p:nvPr/>
        </p:nvPicPr>
        <p:blipFill>
          <a:blip r:embed="rId2"/>
          <a:stretch/>
        </p:blipFill>
        <p:spPr>
          <a:xfrm>
            <a:off x="3083040" y="2239920"/>
            <a:ext cx="2977920" cy="2378160"/>
          </a:xfrm>
          <a:prstGeom prst="rect">
            <a:avLst/>
          </a:prstGeom>
          <a:ln w="0">
            <a:noFill/>
          </a:ln>
        </p:spPr>
      </p:pic>
      <p:sp>
        <p:nvSpPr>
          <p:cNvPr id="43" name="TextBox 8"/>
          <p:cNvSpPr/>
          <p:nvPr/>
        </p:nvSpPr>
        <p:spPr>
          <a:xfrm>
            <a:off x="905040" y="20080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CC-07-04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3989520" y="200196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CC-02-09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7010280" y="20080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CC-25-09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8" descr="P3080001.JPG"/>
          <p:cNvPicPr/>
          <p:nvPr/>
        </p:nvPicPr>
        <p:blipFill>
          <a:blip r:embed="rId3"/>
          <a:stretch/>
        </p:blipFill>
        <p:spPr>
          <a:xfrm>
            <a:off x="6111720" y="2238480"/>
            <a:ext cx="2981520" cy="2381040"/>
          </a:xfrm>
          <a:prstGeom prst="rect">
            <a:avLst/>
          </a:prstGeom>
          <a:ln w="0">
            <a:noFill/>
          </a:ln>
        </p:spPr>
      </p:pic>
      <p:sp>
        <p:nvSpPr>
          <p:cNvPr id="47" name="TextBox 7"/>
          <p:cNvSpPr/>
          <p:nvPr/>
        </p:nvSpPr>
        <p:spPr>
          <a:xfrm>
            <a:off x="0" y="6572160"/>
            <a:ext cx="243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(Supplementary Dat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8"/>
          <p:cNvSpPr/>
          <p:nvPr/>
        </p:nvSpPr>
        <p:spPr>
          <a:xfrm>
            <a:off x="76320" y="4657680"/>
            <a:ext cx="89913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S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s showing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stological features of xenografts RCC-07-0408 (clear cell), RCC-02-0908 (papillary) and RCC-25-0908 (poorly differentiated sarcomatoid)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24T08:40:56Z</dcterms:created>
  <dc:creator>xcsatab</dc:creator>
  <dc:description/>
  <dc:language>en-US</dc:language>
  <cp:lastModifiedBy>Lenovo User</cp:lastModifiedBy>
  <dcterms:modified xsi:type="dcterms:W3CDTF">2010-08-18T00:01:24Z</dcterms:modified>
  <cp:revision>20</cp:revision>
  <dc:subject/>
  <dc:title>Slide 1</dc:title>
</cp:coreProperties>
</file>